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3"/>
  </p:notesMasterIdLst>
  <p:sldIdLst>
    <p:sldId id="291" r:id="rId2"/>
  </p:sldIdLst>
  <p:sldSz cx="6492875" cy="6218238"/>
  <p:notesSz cx="7023100" cy="93091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2" pos="3437" userDrawn="1">
          <p15:clr>
            <a:srgbClr val="A4A3A4"/>
          </p15:clr>
        </p15:guide>
        <p15:guide id="3" orient="horz" pos="375" userDrawn="1">
          <p15:clr>
            <a:srgbClr val="A4A3A4"/>
          </p15:clr>
        </p15:guide>
        <p15:guide id="4" pos="1349" userDrawn="1">
          <p15:clr>
            <a:srgbClr val="A4A3A4"/>
          </p15:clr>
        </p15:guide>
        <p15:guide id="5" orient="horz" pos="2031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haudhary, Ritu" initials="CR" lastIdx="1" clrIdx="0">
    <p:extLst>
      <p:ext uri="{19B8F6BF-5375-455C-9EA6-DF929625EA0E}">
        <p15:presenceInfo xmlns:p15="http://schemas.microsoft.com/office/powerpoint/2012/main" userId="S::Ritu.Chaudhary@moffitt.org::e213b328-12f3-42f9-9afb-2fdf354946f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D0DF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7132" autoAdjust="0"/>
    <p:restoredTop sz="90099" autoAdjust="0"/>
  </p:normalViewPr>
  <p:slideViewPr>
    <p:cSldViewPr snapToGrid="0">
      <p:cViewPr varScale="1">
        <p:scale>
          <a:sx n="160" d="100"/>
          <a:sy n="160" d="100"/>
        </p:scale>
        <p:origin x="3736" y="84"/>
      </p:cViewPr>
      <p:guideLst>
        <p:guide pos="3437"/>
        <p:guide orient="horz" pos="375"/>
        <p:guide pos="1349"/>
        <p:guide orient="horz" pos="2031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43343" cy="467072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8132" y="0"/>
            <a:ext cx="3043343" cy="467072"/>
          </a:xfrm>
          <a:prstGeom prst="rect">
            <a:avLst/>
          </a:prstGeom>
        </p:spPr>
        <p:txBody>
          <a:bodyPr vert="horz" lIns="93324" tIns="46662" rIns="93324" bIns="46662" rtlCol="0"/>
          <a:lstStyle>
            <a:lvl1pPr algn="r">
              <a:defRPr sz="1200"/>
            </a:lvl1pPr>
          </a:lstStyle>
          <a:p>
            <a:fld id="{E3D79D2C-534C-49B8-BF89-98F21FED85F5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871663" y="1163638"/>
            <a:ext cx="3279775" cy="31416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324" tIns="46662" rIns="93324" bIns="46662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2310" y="4480004"/>
            <a:ext cx="5618480" cy="3665458"/>
          </a:xfrm>
          <a:prstGeom prst="rect">
            <a:avLst/>
          </a:prstGeom>
        </p:spPr>
        <p:txBody>
          <a:bodyPr vert="horz" lIns="93324" tIns="46662" rIns="93324" bIns="46662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2030"/>
            <a:ext cx="3043343" cy="467071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8132" y="8842030"/>
            <a:ext cx="3043343" cy="467071"/>
          </a:xfrm>
          <a:prstGeom prst="rect">
            <a:avLst/>
          </a:prstGeom>
        </p:spPr>
        <p:txBody>
          <a:bodyPr vert="horz" lIns="93324" tIns="46662" rIns="93324" bIns="46662" rtlCol="0" anchor="b"/>
          <a:lstStyle>
            <a:lvl1pPr algn="r">
              <a:defRPr sz="1200"/>
            </a:lvl1pPr>
          </a:lstStyle>
          <a:p>
            <a:fld id="{3FBF2B51-D0C1-4CC3-B696-54FB44FD7B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64849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1pPr>
    <a:lvl2pPr marL="228760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2pPr>
    <a:lvl3pPr marL="457520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3pPr>
    <a:lvl4pPr marL="686280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4pPr>
    <a:lvl5pPr marL="915040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5pPr>
    <a:lvl6pPr marL="1143799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6pPr>
    <a:lvl7pPr marL="1372559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7pPr>
    <a:lvl8pPr marL="1601319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8pPr>
    <a:lvl9pPr marL="1830079" algn="l" defTabSz="457520" rtl="0" eaLnBrk="1" latinLnBrk="0" hangingPunct="1">
      <a:defRPr sz="6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966" y="1017661"/>
            <a:ext cx="5518944" cy="2164868"/>
          </a:xfrm>
        </p:spPr>
        <p:txBody>
          <a:bodyPr anchor="b"/>
          <a:lstStyle>
            <a:lvl1pPr algn="ctr">
              <a:defRPr sz="42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1610" y="3266015"/>
            <a:ext cx="4869656" cy="1501301"/>
          </a:xfrm>
        </p:spPr>
        <p:txBody>
          <a:bodyPr/>
          <a:lstStyle>
            <a:lvl1pPr marL="0" indent="0" algn="ctr">
              <a:buNone/>
              <a:defRPr sz="1704"/>
            </a:lvl1pPr>
            <a:lvl2pPr marL="324658" indent="0" algn="ctr">
              <a:buNone/>
              <a:defRPr sz="1420"/>
            </a:lvl2pPr>
            <a:lvl3pPr marL="649315" indent="0" algn="ctr">
              <a:buNone/>
              <a:defRPr sz="1278"/>
            </a:lvl3pPr>
            <a:lvl4pPr marL="973973" indent="0" algn="ctr">
              <a:buNone/>
              <a:defRPr sz="1136"/>
            </a:lvl4pPr>
            <a:lvl5pPr marL="1298631" indent="0" algn="ctr">
              <a:buNone/>
              <a:defRPr sz="1136"/>
            </a:lvl5pPr>
            <a:lvl6pPr marL="1623289" indent="0" algn="ctr">
              <a:buNone/>
              <a:defRPr sz="1136"/>
            </a:lvl6pPr>
            <a:lvl7pPr marL="1947946" indent="0" algn="ctr">
              <a:buNone/>
              <a:defRPr sz="1136"/>
            </a:lvl7pPr>
            <a:lvl8pPr marL="2272604" indent="0" algn="ctr">
              <a:buNone/>
              <a:defRPr sz="1136"/>
            </a:lvl8pPr>
            <a:lvl9pPr marL="2597262" indent="0" algn="ctr">
              <a:buNone/>
              <a:defRPr sz="1136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47527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0628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46464" y="331064"/>
            <a:ext cx="1400026" cy="526966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6385" y="331064"/>
            <a:ext cx="4118918" cy="526966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09305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86103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3004" y="1550243"/>
            <a:ext cx="5600105" cy="2586614"/>
          </a:xfrm>
        </p:spPr>
        <p:txBody>
          <a:bodyPr anchor="b"/>
          <a:lstStyle>
            <a:lvl1pPr>
              <a:defRPr sz="42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3004" y="4161327"/>
            <a:ext cx="5600105" cy="1360239"/>
          </a:xfrm>
        </p:spPr>
        <p:txBody>
          <a:bodyPr/>
          <a:lstStyle>
            <a:lvl1pPr marL="0" indent="0">
              <a:buNone/>
              <a:defRPr sz="1704">
                <a:solidFill>
                  <a:schemeClr val="tx1"/>
                </a:solidFill>
              </a:defRPr>
            </a:lvl1pPr>
            <a:lvl2pPr marL="324658" indent="0">
              <a:buNone/>
              <a:defRPr sz="1420">
                <a:solidFill>
                  <a:schemeClr val="tx1">
                    <a:tint val="75000"/>
                  </a:schemeClr>
                </a:solidFill>
              </a:defRPr>
            </a:lvl2pPr>
            <a:lvl3pPr marL="649315" indent="0">
              <a:buNone/>
              <a:defRPr sz="1278">
                <a:solidFill>
                  <a:schemeClr val="tx1">
                    <a:tint val="75000"/>
                  </a:schemeClr>
                </a:solidFill>
              </a:defRPr>
            </a:lvl3pPr>
            <a:lvl4pPr marL="973973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4pPr>
            <a:lvl5pPr marL="1298631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5pPr>
            <a:lvl6pPr marL="1623289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6pPr>
            <a:lvl7pPr marL="1947946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7pPr>
            <a:lvl8pPr marL="2272604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8pPr>
            <a:lvl9pPr marL="2597262" indent="0">
              <a:buNone/>
              <a:defRPr sz="113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5309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6385" y="1655318"/>
            <a:ext cx="2759472" cy="394541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7018" y="1655318"/>
            <a:ext cx="2759472" cy="394541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14088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231" y="331065"/>
            <a:ext cx="5600105" cy="120190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7232" y="1524332"/>
            <a:ext cx="2746790" cy="747052"/>
          </a:xfrm>
        </p:spPr>
        <p:txBody>
          <a:bodyPr anchor="b"/>
          <a:lstStyle>
            <a:lvl1pPr marL="0" indent="0">
              <a:buNone/>
              <a:defRPr sz="1704" b="1"/>
            </a:lvl1pPr>
            <a:lvl2pPr marL="324658" indent="0">
              <a:buNone/>
              <a:defRPr sz="1420" b="1"/>
            </a:lvl2pPr>
            <a:lvl3pPr marL="649315" indent="0">
              <a:buNone/>
              <a:defRPr sz="1278" b="1"/>
            </a:lvl3pPr>
            <a:lvl4pPr marL="973973" indent="0">
              <a:buNone/>
              <a:defRPr sz="1136" b="1"/>
            </a:lvl4pPr>
            <a:lvl5pPr marL="1298631" indent="0">
              <a:buNone/>
              <a:defRPr sz="1136" b="1"/>
            </a:lvl5pPr>
            <a:lvl6pPr marL="1623289" indent="0">
              <a:buNone/>
              <a:defRPr sz="1136" b="1"/>
            </a:lvl6pPr>
            <a:lvl7pPr marL="1947946" indent="0">
              <a:buNone/>
              <a:defRPr sz="1136" b="1"/>
            </a:lvl7pPr>
            <a:lvl8pPr marL="2272604" indent="0">
              <a:buNone/>
              <a:defRPr sz="1136" b="1"/>
            </a:lvl8pPr>
            <a:lvl9pPr marL="2597262" indent="0">
              <a:buNone/>
              <a:defRPr sz="113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7232" y="2271384"/>
            <a:ext cx="2746790" cy="334086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7018" y="1524332"/>
            <a:ext cx="2760318" cy="747052"/>
          </a:xfrm>
        </p:spPr>
        <p:txBody>
          <a:bodyPr anchor="b"/>
          <a:lstStyle>
            <a:lvl1pPr marL="0" indent="0">
              <a:buNone/>
              <a:defRPr sz="1704" b="1"/>
            </a:lvl1pPr>
            <a:lvl2pPr marL="324658" indent="0">
              <a:buNone/>
              <a:defRPr sz="1420" b="1"/>
            </a:lvl2pPr>
            <a:lvl3pPr marL="649315" indent="0">
              <a:buNone/>
              <a:defRPr sz="1278" b="1"/>
            </a:lvl3pPr>
            <a:lvl4pPr marL="973973" indent="0">
              <a:buNone/>
              <a:defRPr sz="1136" b="1"/>
            </a:lvl4pPr>
            <a:lvl5pPr marL="1298631" indent="0">
              <a:buNone/>
              <a:defRPr sz="1136" b="1"/>
            </a:lvl5pPr>
            <a:lvl6pPr marL="1623289" indent="0">
              <a:buNone/>
              <a:defRPr sz="1136" b="1"/>
            </a:lvl6pPr>
            <a:lvl7pPr marL="1947946" indent="0">
              <a:buNone/>
              <a:defRPr sz="1136" b="1"/>
            </a:lvl7pPr>
            <a:lvl8pPr marL="2272604" indent="0">
              <a:buNone/>
              <a:defRPr sz="1136" b="1"/>
            </a:lvl8pPr>
            <a:lvl9pPr marL="2597262" indent="0">
              <a:buNone/>
              <a:defRPr sz="113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7018" y="2271384"/>
            <a:ext cx="2760318" cy="334086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38700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06389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33781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231" y="414549"/>
            <a:ext cx="2094121" cy="1450922"/>
          </a:xfrm>
        </p:spPr>
        <p:txBody>
          <a:bodyPr anchor="b"/>
          <a:lstStyle>
            <a:lvl1pPr>
              <a:defRPr sz="227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60318" y="895313"/>
            <a:ext cx="3287018" cy="4418979"/>
          </a:xfrm>
        </p:spPr>
        <p:txBody>
          <a:bodyPr/>
          <a:lstStyle>
            <a:lvl1pPr>
              <a:defRPr sz="2272"/>
            </a:lvl1pPr>
            <a:lvl2pPr>
              <a:defRPr sz="1988"/>
            </a:lvl2pPr>
            <a:lvl3pPr>
              <a:defRPr sz="1704"/>
            </a:lvl3pPr>
            <a:lvl4pPr>
              <a:defRPr sz="1420"/>
            </a:lvl4pPr>
            <a:lvl5pPr>
              <a:defRPr sz="1420"/>
            </a:lvl5pPr>
            <a:lvl6pPr>
              <a:defRPr sz="1420"/>
            </a:lvl6pPr>
            <a:lvl7pPr>
              <a:defRPr sz="1420"/>
            </a:lvl7pPr>
            <a:lvl8pPr>
              <a:defRPr sz="1420"/>
            </a:lvl8pPr>
            <a:lvl9pPr>
              <a:defRPr sz="142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7231" y="1865471"/>
            <a:ext cx="2094121" cy="3456017"/>
          </a:xfrm>
        </p:spPr>
        <p:txBody>
          <a:bodyPr/>
          <a:lstStyle>
            <a:lvl1pPr marL="0" indent="0">
              <a:buNone/>
              <a:defRPr sz="1136"/>
            </a:lvl1pPr>
            <a:lvl2pPr marL="324658" indent="0">
              <a:buNone/>
              <a:defRPr sz="994"/>
            </a:lvl2pPr>
            <a:lvl3pPr marL="649315" indent="0">
              <a:buNone/>
              <a:defRPr sz="852"/>
            </a:lvl3pPr>
            <a:lvl4pPr marL="973973" indent="0">
              <a:buNone/>
              <a:defRPr sz="710"/>
            </a:lvl4pPr>
            <a:lvl5pPr marL="1298631" indent="0">
              <a:buNone/>
              <a:defRPr sz="710"/>
            </a:lvl5pPr>
            <a:lvl6pPr marL="1623289" indent="0">
              <a:buNone/>
              <a:defRPr sz="710"/>
            </a:lvl6pPr>
            <a:lvl7pPr marL="1947946" indent="0">
              <a:buNone/>
              <a:defRPr sz="710"/>
            </a:lvl7pPr>
            <a:lvl8pPr marL="2272604" indent="0">
              <a:buNone/>
              <a:defRPr sz="710"/>
            </a:lvl8pPr>
            <a:lvl9pPr marL="2597262" indent="0">
              <a:buNone/>
              <a:defRPr sz="7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3801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7231" y="414549"/>
            <a:ext cx="2094121" cy="1450922"/>
          </a:xfrm>
        </p:spPr>
        <p:txBody>
          <a:bodyPr anchor="b"/>
          <a:lstStyle>
            <a:lvl1pPr>
              <a:defRPr sz="227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60318" y="895313"/>
            <a:ext cx="3287018" cy="4418979"/>
          </a:xfrm>
        </p:spPr>
        <p:txBody>
          <a:bodyPr anchor="t"/>
          <a:lstStyle>
            <a:lvl1pPr marL="0" indent="0">
              <a:buNone/>
              <a:defRPr sz="2272"/>
            </a:lvl1pPr>
            <a:lvl2pPr marL="324658" indent="0">
              <a:buNone/>
              <a:defRPr sz="1988"/>
            </a:lvl2pPr>
            <a:lvl3pPr marL="649315" indent="0">
              <a:buNone/>
              <a:defRPr sz="1704"/>
            </a:lvl3pPr>
            <a:lvl4pPr marL="973973" indent="0">
              <a:buNone/>
              <a:defRPr sz="1420"/>
            </a:lvl4pPr>
            <a:lvl5pPr marL="1298631" indent="0">
              <a:buNone/>
              <a:defRPr sz="1420"/>
            </a:lvl5pPr>
            <a:lvl6pPr marL="1623289" indent="0">
              <a:buNone/>
              <a:defRPr sz="1420"/>
            </a:lvl6pPr>
            <a:lvl7pPr marL="1947946" indent="0">
              <a:buNone/>
              <a:defRPr sz="1420"/>
            </a:lvl7pPr>
            <a:lvl8pPr marL="2272604" indent="0">
              <a:buNone/>
              <a:defRPr sz="1420"/>
            </a:lvl8pPr>
            <a:lvl9pPr marL="2597262" indent="0">
              <a:buNone/>
              <a:defRPr sz="142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7231" y="1865471"/>
            <a:ext cx="2094121" cy="3456017"/>
          </a:xfrm>
        </p:spPr>
        <p:txBody>
          <a:bodyPr/>
          <a:lstStyle>
            <a:lvl1pPr marL="0" indent="0">
              <a:buNone/>
              <a:defRPr sz="1136"/>
            </a:lvl1pPr>
            <a:lvl2pPr marL="324658" indent="0">
              <a:buNone/>
              <a:defRPr sz="994"/>
            </a:lvl2pPr>
            <a:lvl3pPr marL="649315" indent="0">
              <a:buNone/>
              <a:defRPr sz="852"/>
            </a:lvl3pPr>
            <a:lvl4pPr marL="973973" indent="0">
              <a:buNone/>
              <a:defRPr sz="710"/>
            </a:lvl4pPr>
            <a:lvl5pPr marL="1298631" indent="0">
              <a:buNone/>
              <a:defRPr sz="710"/>
            </a:lvl5pPr>
            <a:lvl6pPr marL="1623289" indent="0">
              <a:buNone/>
              <a:defRPr sz="710"/>
            </a:lvl6pPr>
            <a:lvl7pPr marL="1947946" indent="0">
              <a:buNone/>
              <a:defRPr sz="710"/>
            </a:lvl7pPr>
            <a:lvl8pPr marL="2272604" indent="0">
              <a:buNone/>
              <a:defRPr sz="710"/>
            </a:lvl8pPr>
            <a:lvl9pPr marL="2597262" indent="0">
              <a:buNone/>
              <a:defRPr sz="7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990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6385" y="331065"/>
            <a:ext cx="5600105" cy="12019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85" y="1655318"/>
            <a:ext cx="5600105" cy="394541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6385" y="5763387"/>
            <a:ext cx="1460897" cy="3310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504744-D762-4FA9-83A1-E1340F6E5704}" type="datetimeFigureOut">
              <a:rPr lang="en-US" smtClean="0"/>
              <a:t>4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50765" y="5763387"/>
            <a:ext cx="2191345" cy="3310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85593" y="5763387"/>
            <a:ext cx="1460897" cy="33106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E52207-34FF-4BDB-8379-43FB9D3EEC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42525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49315" rtl="0" eaLnBrk="1" latinLnBrk="0" hangingPunct="1">
        <a:lnSpc>
          <a:spcPct val="90000"/>
        </a:lnSpc>
        <a:spcBef>
          <a:spcPct val="0"/>
        </a:spcBef>
        <a:buNone/>
        <a:defRPr sz="312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329" indent="-162329" algn="l" defTabSz="649315" rtl="0" eaLnBrk="1" latinLnBrk="0" hangingPunct="1">
        <a:lnSpc>
          <a:spcPct val="90000"/>
        </a:lnSpc>
        <a:spcBef>
          <a:spcPts val="710"/>
        </a:spcBef>
        <a:buFont typeface="Arial" panose="020B0604020202020204" pitchFamily="34" charset="0"/>
        <a:buChar char="•"/>
        <a:defRPr sz="1988" kern="1200">
          <a:solidFill>
            <a:schemeClr val="tx1"/>
          </a:solidFill>
          <a:latin typeface="+mn-lt"/>
          <a:ea typeface="+mn-ea"/>
          <a:cs typeface="+mn-cs"/>
        </a:defRPr>
      </a:lvl1pPr>
      <a:lvl2pPr marL="486987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704" kern="1200">
          <a:solidFill>
            <a:schemeClr val="tx1"/>
          </a:solidFill>
          <a:latin typeface="+mn-lt"/>
          <a:ea typeface="+mn-ea"/>
          <a:cs typeface="+mn-cs"/>
        </a:defRPr>
      </a:lvl2pPr>
      <a:lvl3pPr marL="811644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420" kern="1200">
          <a:solidFill>
            <a:schemeClr val="tx1"/>
          </a:solidFill>
          <a:latin typeface="+mn-lt"/>
          <a:ea typeface="+mn-ea"/>
          <a:cs typeface="+mn-cs"/>
        </a:defRPr>
      </a:lvl3pPr>
      <a:lvl4pPr marL="1136302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4pPr>
      <a:lvl5pPr marL="1460960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5pPr>
      <a:lvl6pPr marL="1785617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6pPr>
      <a:lvl7pPr marL="2110275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7pPr>
      <a:lvl8pPr marL="2434933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8pPr>
      <a:lvl9pPr marL="2759591" indent="-162329" algn="l" defTabSz="649315" rtl="0" eaLnBrk="1" latinLnBrk="0" hangingPunct="1">
        <a:lnSpc>
          <a:spcPct val="90000"/>
        </a:lnSpc>
        <a:spcBef>
          <a:spcPts val="355"/>
        </a:spcBef>
        <a:buFont typeface="Arial" panose="020B0604020202020204" pitchFamily="34" charset="0"/>
        <a:buChar char="•"/>
        <a:defRPr sz="127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1pPr>
      <a:lvl2pPr marL="324658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2pPr>
      <a:lvl3pPr marL="649315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3pPr>
      <a:lvl4pPr marL="973973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4pPr>
      <a:lvl5pPr marL="1298631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5pPr>
      <a:lvl6pPr marL="1623289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6pPr>
      <a:lvl7pPr marL="1947946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7pPr>
      <a:lvl8pPr marL="2272604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8pPr>
      <a:lvl9pPr marL="2597262" algn="l" defTabSz="649315" rtl="0" eaLnBrk="1" latinLnBrk="0" hangingPunct="1">
        <a:defRPr sz="127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6CCEBDDA-7EC7-41A4-9523-A0AC5045E3F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0213" y="853978"/>
            <a:ext cx="1933075" cy="2182597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2C8C32EC-4FAE-4110-A720-641219F0C1A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76606" y="853978"/>
            <a:ext cx="1864241" cy="2185465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6A7C7EAF-E2F8-438B-9ECE-62F5C58A673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49475" y="853978"/>
            <a:ext cx="2159652" cy="2179729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3E4AB26-6785-433B-8DF3-D42AAA5071FD}"/>
              </a:ext>
            </a:extLst>
          </p:cNvPr>
          <p:cNvSpPr txBox="1"/>
          <p:nvPr/>
        </p:nvSpPr>
        <p:spPr>
          <a:xfrm>
            <a:off x="1201820" y="662972"/>
            <a:ext cx="6477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E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040071EE-92A4-4103-9827-28328F28266F}"/>
              </a:ext>
            </a:extLst>
          </p:cNvPr>
          <p:cNvSpPr txBox="1"/>
          <p:nvPr/>
        </p:nvSpPr>
        <p:spPr>
          <a:xfrm>
            <a:off x="3317116" y="662972"/>
            <a:ext cx="6477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E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4CB4AC0-E110-4A8A-802C-1FCBC1ED810B}"/>
              </a:ext>
            </a:extLst>
          </p:cNvPr>
          <p:cNvSpPr txBox="1"/>
          <p:nvPr/>
        </p:nvSpPr>
        <p:spPr>
          <a:xfrm>
            <a:off x="5487929" y="662972"/>
            <a:ext cx="64770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E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E057CFA-D564-48FB-92E5-7A4A58D455D8}"/>
              </a:ext>
            </a:extLst>
          </p:cNvPr>
          <p:cNvSpPr txBox="1"/>
          <p:nvPr/>
        </p:nvSpPr>
        <p:spPr>
          <a:xfrm>
            <a:off x="835205" y="435620"/>
            <a:ext cx="142308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mmune vs Hypoxi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C8BFA57-F672-47BF-AEC6-3C20C4D52DDE}"/>
              </a:ext>
            </a:extLst>
          </p:cNvPr>
          <p:cNvSpPr txBox="1"/>
          <p:nvPr/>
        </p:nvSpPr>
        <p:spPr>
          <a:xfrm>
            <a:off x="2924172" y="435620"/>
            <a:ext cx="142308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>
            <a:defPPr>
              <a:defRPr lang="en-US"/>
            </a:defPPr>
            <a:lvl1pPr algn="ctr">
              <a:defRPr sz="2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000" dirty="0"/>
              <a:t>Immune vs Mixtur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FA98473-F00E-4880-9C67-D0CD2FE17483}"/>
              </a:ext>
            </a:extLst>
          </p:cNvPr>
          <p:cNvSpPr txBox="1"/>
          <p:nvPr/>
        </p:nvSpPr>
        <p:spPr>
          <a:xfrm>
            <a:off x="4669808" y="435620"/>
            <a:ext cx="1423080" cy="246221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>
            <a:defPPr>
              <a:defRPr lang="en-US"/>
            </a:defPPr>
            <a:lvl1pPr algn="ctr">
              <a:defRPr sz="2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1000" dirty="0"/>
              <a:t>Hypoxia vs Mixtur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CFA4274-8BC5-4973-A978-B788CF52AE99}"/>
              </a:ext>
            </a:extLst>
          </p:cNvPr>
          <p:cNvSpPr txBox="1"/>
          <p:nvPr/>
        </p:nvSpPr>
        <p:spPr>
          <a:xfrm>
            <a:off x="4951924" y="26748"/>
            <a:ext cx="15959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AFB8591-0B8C-4521-B71F-4CC4A8895D79}"/>
              </a:ext>
            </a:extLst>
          </p:cNvPr>
          <p:cNvSpPr txBox="1"/>
          <p:nvPr/>
        </p:nvSpPr>
        <p:spPr>
          <a:xfrm>
            <a:off x="35168" y="356446"/>
            <a:ext cx="6429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428E93E-3402-473D-B22E-B60E500AE71E}"/>
              </a:ext>
            </a:extLst>
          </p:cNvPr>
          <p:cNvSpPr txBox="1"/>
          <p:nvPr/>
        </p:nvSpPr>
        <p:spPr>
          <a:xfrm>
            <a:off x="2323606" y="356446"/>
            <a:ext cx="6429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5ED7677-F63D-4E39-8E6E-A9F9A6335F6F}"/>
              </a:ext>
            </a:extLst>
          </p:cNvPr>
          <p:cNvSpPr txBox="1"/>
          <p:nvPr/>
        </p:nvSpPr>
        <p:spPr>
          <a:xfrm>
            <a:off x="4497069" y="356446"/>
            <a:ext cx="6429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00AB7F7-1736-4CD5-9202-89FB169BCFF6}"/>
              </a:ext>
            </a:extLst>
          </p:cNvPr>
          <p:cNvSpPr txBox="1"/>
          <p:nvPr/>
        </p:nvSpPr>
        <p:spPr>
          <a:xfrm>
            <a:off x="140213" y="3323492"/>
            <a:ext cx="6268914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Supplementary Figure 4: 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(A-C) Clinical Proteomic Tumor Analysis Consortium head and neck squamous cell carcinoma cohort. The gene expressions were compared for pathways enriched in: (A) Immune vs Hypoxia. Red: enriched in Immune, Blue: enriched in Hypoxia. (B) Immune vs Mixture. Red: enriched in Immune, Blue: enriched in Mixture. (C) Hypoxia vs Mixture. Red: enriched in Hypoxia, Blue: enriched in Mixture. Indicated are the top 10 most differentially expressed pathways in Cancer Hallmarks gene sets. NES: Normalized Enrichment Score</a:t>
            </a:r>
            <a:endParaRPr lang="en-US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3512668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714</TotalTime>
  <Words>125</Words>
  <Application>Microsoft Office PowerPoint</Application>
  <PresentationFormat>Custom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udhary, Ritu</dc:creator>
  <cp:lastModifiedBy>Chung, Christine H</cp:lastModifiedBy>
  <cp:revision>383</cp:revision>
  <cp:lastPrinted>2022-01-03T15:25:01Z</cp:lastPrinted>
  <dcterms:created xsi:type="dcterms:W3CDTF">2021-01-11T21:01:01Z</dcterms:created>
  <dcterms:modified xsi:type="dcterms:W3CDTF">2023-04-30T13:05:15Z</dcterms:modified>
</cp:coreProperties>
</file>